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2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-1434" y="-84"/>
      </p:cViewPr>
      <p:guideLst>
        <p:guide orient="horz" pos="23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954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04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054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81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627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6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30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47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4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165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65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71947" y="768503"/>
            <a:ext cx="3220482" cy="33094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588" dirty="0">
                <a:latin typeface="Arial" panose="020B0604020202020204" pitchFamily="34" charset="0"/>
                <a:cs typeface="Arial" panose="020B0604020202020204" pitchFamily="34" charset="0"/>
              </a:rPr>
              <a:t>Seachrist, Darcie et al</a:t>
            </a:r>
            <a:r>
              <a:rPr lang="en-US" sz="1588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en-US" sz="1588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588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US" sz="15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715068" y="1867984"/>
            <a:ext cx="2459784" cy="4327912"/>
            <a:chOff x="554648" y="2119849"/>
            <a:chExt cx="2787755" cy="4904967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9" t="11255" r="5586" b="15980"/>
            <a:stretch/>
          </p:blipFill>
          <p:spPr>
            <a:xfrm>
              <a:off x="818910" y="4739366"/>
              <a:ext cx="2506999" cy="2075688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0" t="11255" r="5586" b="16925"/>
            <a:stretch/>
          </p:blipFill>
          <p:spPr>
            <a:xfrm>
              <a:off x="802416" y="2119849"/>
              <a:ext cx="2539987" cy="2075688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275982" y="2945278"/>
              <a:ext cx="793969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75983" y="5551692"/>
              <a:ext cx="793969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18709" y="4174015"/>
              <a:ext cx="990177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n-US" sz="79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  <a:endParaRPr lang="en-US" sz="79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618709" y="6788178"/>
              <a:ext cx="990177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n-US" sz="79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  <a:endParaRPr lang="en-US" sz="79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252"/>
            <p:cNvSpPr txBox="1">
              <a:spLocks noChangeArrowheads="1"/>
            </p:cNvSpPr>
            <p:nvPr/>
          </p:nvSpPr>
          <p:spPr bwMode="auto">
            <a:xfrm>
              <a:off x="1653062" y="3544809"/>
              <a:ext cx="1117494" cy="498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5749" tIns="42874" rIns="85749" bIns="42874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168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47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26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05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324" b="1" dirty="0"/>
                <a:t>Luminal A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71" dirty="0"/>
                <a:t>1764 patients </a:t>
              </a:r>
            </a:p>
          </p:txBody>
        </p:sp>
        <p:sp>
          <p:nvSpPr>
            <p:cNvPr id="21" name="TextBox 252"/>
            <p:cNvSpPr txBox="1">
              <a:spLocks noChangeArrowheads="1"/>
            </p:cNvSpPr>
            <p:nvPr/>
          </p:nvSpPr>
          <p:spPr bwMode="auto">
            <a:xfrm>
              <a:off x="1781540" y="6151222"/>
              <a:ext cx="1004711" cy="498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5749" tIns="42874" rIns="85749" bIns="42874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168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47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26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05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324" b="1" dirty="0"/>
                <a:t>HER2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71" dirty="0"/>
                <a:t>208 patients </a:t>
              </a: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3225678" y="1867984"/>
            <a:ext cx="2450622" cy="4327912"/>
            <a:chOff x="3937601" y="2119849"/>
            <a:chExt cx="2777371" cy="4904967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9" t="11255" r="5586" b="16925"/>
            <a:stretch/>
          </p:blipFill>
          <p:spPr>
            <a:xfrm>
              <a:off x="4174986" y="4739366"/>
              <a:ext cx="2539986" cy="2075688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19" t="10876" r="5152" b="16358"/>
            <a:stretch/>
          </p:blipFill>
          <p:spPr>
            <a:xfrm>
              <a:off x="4174986" y="2119849"/>
              <a:ext cx="2533957" cy="2075688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 rot="16200000">
              <a:off x="3658935" y="2998136"/>
              <a:ext cx="793969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658936" y="5604549"/>
              <a:ext cx="793969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955228" y="4174015"/>
              <a:ext cx="990177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n-US" sz="79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  <a:endParaRPr lang="en-US" sz="79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955228" y="6788178"/>
              <a:ext cx="990177" cy="236638"/>
            </a:xfrm>
            <a:prstGeom prst="rect">
              <a:avLst/>
            </a:prstGeom>
            <a:noFill/>
          </p:spPr>
          <p:txBody>
            <a:bodyPr wrap="none" lIns="85749" tIns="42874" rIns="85749" bIns="42874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n-US" sz="79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  <a:endParaRPr lang="en-US" sz="79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252"/>
            <p:cNvSpPr txBox="1">
              <a:spLocks noChangeArrowheads="1"/>
            </p:cNvSpPr>
            <p:nvPr/>
          </p:nvSpPr>
          <p:spPr bwMode="auto">
            <a:xfrm>
              <a:off x="5013053" y="3544808"/>
              <a:ext cx="1124615" cy="498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5749" tIns="42874" rIns="85749" bIns="42874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168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47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26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05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324" b="1" dirty="0"/>
                <a:t>Luminal B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71" dirty="0"/>
                <a:t>1002 patients </a:t>
              </a:r>
            </a:p>
          </p:txBody>
        </p:sp>
        <p:sp>
          <p:nvSpPr>
            <p:cNvPr id="22" name="TextBox 252"/>
            <p:cNvSpPr txBox="1">
              <a:spLocks noChangeArrowheads="1"/>
            </p:cNvSpPr>
            <p:nvPr/>
          </p:nvSpPr>
          <p:spPr bwMode="auto">
            <a:xfrm>
              <a:off x="5151124" y="6175527"/>
              <a:ext cx="1004711" cy="498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5749" tIns="42874" rIns="85749" bIns="42874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168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47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26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05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05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324" b="1" dirty="0"/>
                <a:t>Basal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71" dirty="0"/>
                <a:t>580 patients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16803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1</TotalTime>
  <Words>42</Words>
  <Application>Microsoft Office PowerPoint</Application>
  <PresentationFormat>Letter Paper (8.5x11 in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WRU S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ds8@case.edu</dc:creator>
  <cp:lastModifiedBy>Balindan, Danica Joy</cp:lastModifiedBy>
  <cp:revision>30</cp:revision>
  <dcterms:created xsi:type="dcterms:W3CDTF">2016-12-05T21:51:29Z</dcterms:created>
  <dcterms:modified xsi:type="dcterms:W3CDTF">2017-05-29T04:54:29Z</dcterms:modified>
</cp:coreProperties>
</file>